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164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834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029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8902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374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8411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415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0679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3554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2874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757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644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E4A5C-1978-4F6D-8669-963521DA80BC}" type="datetimeFigureOut">
              <a:rPr lang="zh-CN" altLang="en-US" smtClean="0"/>
              <a:t>2022-06-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E9622-103B-4C8E-BBA0-94C6577F0A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5592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FCDBDC04-DC20-4F68-A081-6B5477DA54B2}"/>
              </a:ext>
            </a:extLst>
          </p:cNvPr>
          <p:cNvSpPr txBox="1"/>
          <p:nvPr/>
        </p:nvSpPr>
        <p:spPr>
          <a:xfrm>
            <a:off x="866776" y="5002642"/>
            <a:ext cx="7643812" cy="8794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Comparison of metabolite abundance in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scuta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aponica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tached to the host and non-host plants at 24 h (A) and 72 h (B)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8463"/>
            <a:ext cx="9144000" cy="3995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3431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31E5B04E-711C-4A56-96D8-EED1DBFC6882}"/>
              </a:ext>
            </a:extLst>
          </p:cNvPr>
          <p:cNvSpPr txBox="1"/>
          <p:nvPr/>
        </p:nvSpPr>
        <p:spPr>
          <a:xfrm>
            <a:off x="1171574" y="5666899"/>
            <a:ext cx="762476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Figure S2: Number of differentially clustered metabolites in the </a:t>
            </a:r>
            <a:r>
              <a:rPr lang="en-US" altLang="zh-CN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HTD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(A) and </a:t>
            </a:r>
            <a:r>
              <a:rPr lang="en-US" altLang="zh-CN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MTD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(B) groups. The metabolite abundance trends of the differentially clustered profiles in the </a:t>
            </a:r>
            <a:r>
              <a:rPr lang="en-US" altLang="zh-CN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HTD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(C) and </a:t>
            </a:r>
            <a:r>
              <a:rPr lang="en-US" altLang="zh-CN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MTD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(D) groups are shown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7510" y="141310"/>
            <a:ext cx="4058527" cy="55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88486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765CBB57-C073-4FDA-97B1-6791F7135AF7}"/>
              </a:ext>
            </a:extLst>
          </p:cNvPr>
          <p:cNvSpPr txBox="1"/>
          <p:nvPr/>
        </p:nvSpPr>
        <p:spPr>
          <a:xfrm>
            <a:off x="603612" y="5723308"/>
            <a:ext cx="7920037" cy="8794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: Number of differentially clustered genes in the </a:t>
            </a:r>
            <a:r>
              <a:rPr lang="en-US" altLang="zh-CN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TD 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and </a:t>
            </a:r>
            <a:r>
              <a:rPr lang="en-US" altLang="zh-CN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D 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groups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416" y="91759"/>
            <a:ext cx="4234233" cy="55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6625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93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ui kang</dc:creator>
  <cp:lastModifiedBy>Windows User</cp:lastModifiedBy>
  <cp:revision>2</cp:revision>
  <dcterms:created xsi:type="dcterms:W3CDTF">2022-02-08T04:10:41Z</dcterms:created>
  <dcterms:modified xsi:type="dcterms:W3CDTF">2022-06-22T06:54:05Z</dcterms:modified>
</cp:coreProperties>
</file>